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00"/>
    <a:srgbClr val="9DC3E6"/>
    <a:srgbClr val="FFFFFF"/>
    <a:srgbClr val="C5C5C5"/>
    <a:srgbClr val="C5A646"/>
    <a:srgbClr val="B6D2EC"/>
    <a:srgbClr val="FF66FF"/>
    <a:srgbClr val="FFCCFF"/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0219" autoAdjust="0"/>
  </p:normalViewPr>
  <p:slideViewPr>
    <p:cSldViewPr snapToGrid="0">
      <p:cViewPr varScale="1">
        <p:scale>
          <a:sx n="86" d="100"/>
          <a:sy n="86" d="100"/>
        </p:scale>
        <p:origin x="1339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ubstituent ante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ubstituent dată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A305D1-AF2A-4991-9AFD-6D0AA166C818}" type="datetimeFigureOut">
              <a:rPr lang="en-US" smtClean="0"/>
              <a:t>10/31/2023</a:t>
            </a:fld>
            <a:endParaRPr lang="en-US"/>
          </a:p>
        </p:txBody>
      </p:sp>
      <p:sp>
        <p:nvSpPr>
          <p:cNvPr id="4" name="Substituent imagine diapozitiv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Substituent note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o-RO"/>
              <a:t>Faceți clic pentru a edita stilurile de text Coordonator</a:t>
            </a:r>
          </a:p>
          <a:p>
            <a:pPr lvl="1"/>
            <a:r>
              <a:rPr lang="ro-RO"/>
              <a:t>Al doilea nivel</a:t>
            </a:r>
          </a:p>
          <a:p>
            <a:pPr lvl="2"/>
            <a:r>
              <a:rPr lang="ro-RO"/>
              <a:t>Al treilea nivel</a:t>
            </a:r>
          </a:p>
          <a:p>
            <a:pPr lvl="3"/>
            <a:r>
              <a:rPr lang="ro-RO"/>
              <a:t>Al patrulea nivel</a:t>
            </a:r>
          </a:p>
          <a:p>
            <a:pPr lvl="4"/>
            <a:r>
              <a:rPr lang="ro-RO"/>
              <a:t>Al cincilea nivel</a:t>
            </a:r>
            <a:endParaRPr lang="en-US"/>
          </a:p>
        </p:txBody>
      </p:sp>
      <p:sp>
        <p:nvSpPr>
          <p:cNvPr id="6" name="Substituent subsol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ubstituent număr diapozitiv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C8BD7E-DE10-4080-B1D6-DF1C4A6000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08744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ubstituent imagine diapozitiv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ubstituent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ubstituent număr diapozitiv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5C8BD7E-DE10-4080-B1D6-DF1C4A60000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34514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pPr/>
              <a:t>10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504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pPr/>
              <a:t>10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673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pPr/>
              <a:t>10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186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pPr/>
              <a:t>10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3861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pPr/>
              <a:t>10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1970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pPr/>
              <a:t>10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3529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pPr/>
              <a:t>10/3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5390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pPr/>
              <a:t>10/3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456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pPr/>
              <a:t>10/3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739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pPr/>
              <a:t>10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873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804347-0BAC-4858-82A8-6D72002672E5}" type="datetimeFigureOut">
              <a:rPr lang="en-US" smtClean="0"/>
              <a:pPr/>
              <a:t>10/3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E3DDA6-4BED-4908-8B6C-DAD477D80E2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3043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804347-0BAC-4858-82A8-6D72002672E5}" type="datetimeFigureOut">
              <a:rPr lang="en-US" smtClean="0"/>
              <a:pPr/>
              <a:t>10/3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E3DDA6-4BED-4908-8B6C-DAD477D80E2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154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ncbi.nlm.nih.gov/nuccore/NM_017196.3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www.ncbi.nlm.nih.gov/gene/29427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400153" y="929323"/>
            <a:ext cx="6614002" cy="3045947"/>
            <a:chOff x="1400153" y="1618437"/>
            <a:chExt cx="6614002" cy="3045947"/>
          </a:xfrm>
        </p:grpSpPr>
        <p:grpSp>
          <p:nvGrpSpPr>
            <p:cNvPr id="32" name="Grupare 31"/>
            <p:cNvGrpSpPr/>
            <p:nvPr/>
          </p:nvGrpSpPr>
          <p:grpSpPr>
            <a:xfrm>
              <a:off x="1400153" y="1618437"/>
              <a:ext cx="6343693" cy="3045947"/>
              <a:chOff x="1400153" y="874051"/>
              <a:chExt cx="6343693" cy="3045947"/>
            </a:xfrm>
          </p:grpSpPr>
          <p:sp>
            <p:nvSpPr>
              <p:cNvPr id="5" name="CasetăText 4"/>
              <p:cNvSpPr txBox="1"/>
              <p:nvPr/>
            </p:nvSpPr>
            <p:spPr>
              <a:xfrm>
                <a:off x="1552407" y="3489111"/>
                <a:ext cx="2366190" cy="4308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inding site for the </a:t>
                </a:r>
              </a:p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ntisense strand of Iba1 siRNA</a:t>
                </a:r>
              </a:p>
            </p:txBody>
          </p:sp>
          <p:grpSp>
            <p:nvGrpSpPr>
              <p:cNvPr id="31" name="Grupare 30"/>
              <p:cNvGrpSpPr/>
              <p:nvPr/>
            </p:nvGrpSpPr>
            <p:grpSpPr>
              <a:xfrm>
                <a:off x="1400153" y="874051"/>
                <a:ext cx="6343693" cy="2636959"/>
                <a:chOff x="1400153" y="874051"/>
                <a:chExt cx="6343693" cy="2636959"/>
              </a:xfrm>
            </p:grpSpPr>
            <p:sp>
              <p:nvSpPr>
                <p:cNvPr id="2" name="CasetăText 1"/>
                <p:cNvSpPr txBox="1"/>
                <p:nvPr/>
              </p:nvSpPr>
              <p:spPr>
                <a:xfrm>
                  <a:off x="1400153" y="1305342"/>
                  <a:ext cx="6343693" cy="212365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Courier New" pitchFamily="49" charset="0"/>
                      <a:cs typeface="Courier New" pitchFamily="49" charset="0"/>
                    </a:rPr>
                    <a:t>CCAGAAGGGACTGGGGAGCTGGTGGAGAGAGGAGCCAGCCAACACACTGCAGCCTCATCGTCATCTCCCCACCTAAGGCCACCAGCGTCTGAGGAGCT</a:t>
                  </a:r>
                  <a:r>
                    <a:rPr lang="en-US" sz="1200" b="1" dirty="0">
                      <a:solidFill>
                        <a:srgbClr val="FF0000"/>
                      </a:solidFill>
                      <a:latin typeface="Courier New" pitchFamily="49" charset="0"/>
                      <a:cs typeface="Courier New" pitchFamily="49" charset="0"/>
                    </a:rPr>
                    <a:t>ATG</a:t>
                  </a:r>
                  <a:r>
                    <a:rPr lang="en-US" sz="1200" dirty="0">
                      <a:solidFill>
                        <a:schemeClr val="accent1">
                          <a:lumMod val="75000"/>
                        </a:schemeClr>
                      </a:solidFill>
                      <a:latin typeface="Courier New" pitchFamily="49" charset="0"/>
                      <a:cs typeface="Courier New" pitchFamily="49" charset="0"/>
                    </a:rPr>
                    <a:t>AGCCAGAGCAAGGATTTGCAGGGAGGAAAAGCTTTTGGACTGCTGAAAGCCCAACAGGAAGAGAGGTTGGATGGGATCAACAAGCACTTCCTCGATGATCCCAAGTACAGCAGTGATGAGGATCTGCAGTCCAAACTGGAGGCCTTCAAGA</a:t>
                  </a:r>
                  <a:r>
                    <a:rPr lang="en-US" sz="1200" b="1" dirty="0">
                      <a:solidFill>
                        <a:srgbClr val="FF0000"/>
                      </a:solidFill>
                      <a:latin typeface="Courier New" pitchFamily="49" charset="0"/>
                      <a:cs typeface="Courier New" pitchFamily="49" charset="0"/>
                    </a:rPr>
                    <a:t>C</a:t>
                  </a:r>
                  <a:r>
                    <a:rPr lang="en-US" sz="1200" dirty="0">
                      <a:solidFill>
                        <a:srgbClr val="FF0000"/>
                      </a:solidFill>
                      <a:latin typeface="Courier New" pitchFamily="49" charset="0"/>
                      <a:cs typeface="Courier New" pitchFamily="49" charset="0"/>
                    </a:rPr>
                    <a:t>GAAGTACATGGAGTTTGATCTGAA</a:t>
                  </a:r>
                  <a:r>
                    <a:rPr lang="en-US" sz="1200" b="1" u="sng" dirty="0">
                      <a:solidFill>
                        <a:srgbClr val="FF0000"/>
                      </a:solidFill>
                      <a:effectLst>
                        <a:glow rad="127000">
                          <a:srgbClr val="FFFF00"/>
                        </a:glow>
                      </a:effectLst>
                      <a:latin typeface="Courier New" pitchFamily="49" charset="0"/>
                      <a:cs typeface="Courier New" pitchFamily="49" charset="0"/>
                    </a:rPr>
                    <a:t>TGGCAATGGAGATATCGAT</a:t>
                  </a:r>
                  <a:r>
                    <a:rPr lang="en-US" sz="1200" dirty="0">
                      <a:solidFill>
                        <a:schemeClr val="accent1">
                          <a:lumMod val="75000"/>
                        </a:schemeClr>
                      </a:solidFill>
                      <a:latin typeface="Courier New" pitchFamily="49" charset="0"/>
                      <a:cs typeface="Courier New" pitchFamily="49" charset="0"/>
                    </a:rPr>
                    <a:t>ATTATGTCCTTGAAGCGAATGCTGGAGAAACTTGGGGTTCCCAAGACCCATCTAGAGCTGAAGAAATTAATTAGAGAGGTGTCCAGTGGCTCCGAGGAGACGTTCAGTTACTCTGACTTTCTCAGAATGATGCTGGGCAAGAGATCTGCCATCTTGAGAATGATTCTGATGTATGAGGAGAAAAACAAAGAACACCAGAAGCCAACTGGTCCCCCAGCCAAGAAAGCTATTTCTGAGTTGCCC</a:t>
                  </a:r>
                  <a:r>
                    <a:rPr lang="en-US" sz="1200" b="1" dirty="0">
                      <a:solidFill>
                        <a:schemeClr val="accent1">
                          <a:lumMod val="75000"/>
                        </a:schemeClr>
                      </a:solidFill>
                      <a:latin typeface="Courier New" pitchFamily="49" charset="0"/>
                      <a:cs typeface="Courier New" pitchFamily="49" charset="0"/>
                    </a:rPr>
                    <a:t>TAA</a:t>
                  </a:r>
                  <a:r>
                    <a:rPr lang="en-US" sz="1200" dirty="0">
                      <a:latin typeface="Courier New" pitchFamily="49" charset="0"/>
                      <a:cs typeface="Courier New" pitchFamily="49" charset="0"/>
                    </a:rPr>
                    <a:t>TTGGAGGTGGATATAACACGGTGGGACCGAGGACCTTCTAATGACAGCAGCATGGGAAAAGAAGAAGCAGTTGTGAGCCAGAGTCAAACTAAATAAATAATGCTCCCTAGTGCAAAAAAAAAAAAAAAAAAAAAAAAAAAAAAA</a:t>
                  </a:r>
                </a:p>
              </p:txBody>
            </p:sp>
            <p:sp>
              <p:nvSpPr>
                <p:cNvPr id="4" name="CasetăText 3"/>
                <p:cNvSpPr txBox="1"/>
                <p:nvPr/>
              </p:nvSpPr>
              <p:spPr>
                <a:xfrm>
                  <a:off x="2735502" y="874051"/>
                  <a:ext cx="1403997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ro-RO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itiation codon</a:t>
                  </a:r>
                </a:p>
              </p:txBody>
            </p:sp>
            <p:cxnSp>
              <p:nvCxnSpPr>
                <p:cNvPr id="8" name="Straight Arrow Connector 63"/>
                <p:cNvCxnSpPr/>
                <p:nvPr/>
              </p:nvCxnSpPr>
              <p:spPr>
                <a:xfrm flipV="1">
                  <a:off x="2085975" y="2246769"/>
                  <a:ext cx="627890" cy="1264241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Straight Arrow Connector 63"/>
                <p:cNvCxnSpPr/>
                <p:nvPr/>
              </p:nvCxnSpPr>
              <p:spPr>
                <a:xfrm flipH="1" flipV="1">
                  <a:off x="4292207" y="2215169"/>
                  <a:ext cx="1956193" cy="1273942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Straight Arrow Connector 63"/>
                <p:cNvCxnSpPr/>
                <p:nvPr/>
              </p:nvCxnSpPr>
              <p:spPr>
                <a:xfrm>
                  <a:off x="3362325" y="1082907"/>
                  <a:ext cx="1079541" cy="462470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Straight Arrow Connector 63"/>
                <p:cNvCxnSpPr/>
                <p:nvPr/>
              </p:nvCxnSpPr>
              <p:spPr>
                <a:xfrm flipH="1">
                  <a:off x="6496126" y="1245231"/>
                  <a:ext cx="104699" cy="700794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4" name="CasetăText 4"/>
            <p:cNvSpPr txBox="1"/>
            <p:nvPr/>
          </p:nvSpPr>
          <p:spPr>
            <a:xfrm>
              <a:off x="5679965" y="4184347"/>
              <a:ext cx="19593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ro-RO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The </a:t>
              </a:r>
              <a:r>
                <a:rPr lang="en-GB" sz="105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GB" sz="105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st</a:t>
              </a:r>
              <a:r>
                <a:rPr lang="ro-RO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ro-RO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ucleotide</a:t>
              </a:r>
              <a:r>
                <a:rPr lang="ro-RO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 of Exon 5                                                                   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CasetăText 3"/>
            <p:cNvSpPr txBox="1"/>
            <p:nvPr/>
          </p:nvSpPr>
          <p:spPr>
            <a:xfrm>
              <a:off x="5679965" y="1711317"/>
              <a:ext cx="2334190" cy="2672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ro-RO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he </a:t>
              </a:r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GB" sz="11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st</a:t>
              </a:r>
              <a:r>
                <a:rPr lang="ro-RO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nucleotide of Exon 4</a:t>
              </a:r>
            </a:p>
          </p:txBody>
        </p:sp>
      </p:grpSp>
      <p:sp>
        <p:nvSpPr>
          <p:cNvPr id="7" name="Rectangle 1">
            <a:extLst>
              <a:ext uri="{FF2B5EF4-FFF2-40B4-BE49-F238E27FC236}">
                <a16:creationId xmlns:a16="http://schemas.microsoft.com/office/drawing/2014/main" id="{2304C0DE-0E72-E415-7E4A-114FA0A81EBC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6061" y="4464146"/>
            <a:ext cx="7258113" cy="1292662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kumimoji="0" lang="en-GB" altLang="en-US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kumimoji="0" lang="en-GB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agram showing the position of the nucleotide sequence inside the mRNA molecule where the antisense strand of Iba1-siRNA would bind. The total sequence represents the mRNA coding for 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attus norvegicus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llograft inflammatory factor 1 (Aif1): NCBI Reference Sequence: NM_017196.3 (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https://www.ncbi.nlm.nih.gov/nuccore/NM_017196.3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Gene ID: 29427 (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4"/>
              </a:rPr>
              <a:t>https://www.ncbi.nlm.nih.gov/gene/29427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 In 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70C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lue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s represented the gene coding region, 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s the exon 4 sequence and highlighted in yellow is the sequence to which the antisense strand of Iba1-siRNA would bind. The binding starts at 176 nucleotides from the ATG initiation codon.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>
          <a:defRPr sz="1000" dirty="0" smtClean="0">
            <a:latin typeface="Courier New" pitchFamily="49" charset="0"/>
            <a:cs typeface="Courier New" pitchFamily="49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ă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39</TotalTime>
  <Words>159</Words>
  <Application>Microsoft Office PowerPoint</Application>
  <PresentationFormat>On-screen Show (4:3)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oleta Ristoiu</dc:creator>
  <cp:lastModifiedBy>MDPI</cp:lastModifiedBy>
  <cp:revision>74</cp:revision>
  <cp:lastPrinted>2019-05-21T12:50:41Z</cp:lastPrinted>
  <dcterms:created xsi:type="dcterms:W3CDTF">2019-05-16T10:28:49Z</dcterms:created>
  <dcterms:modified xsi:type="dcterms:W3CDTF">2023-10-31T07:30:12Z</dcterms:modified>
</cp:coreProperties>
</file>